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</p:sldIdLst>
  <p:sldSz cx="7561263" cy="106934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C0000"/>
    <a:srgbClr val="B81504"/>
    <a:srgbClr val="000099"/>
    <a:srgbClr val="FF3300"/>
    <a:srgbClr val="FFCC66"/>
    <a:srgbClr val="66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436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-4080" y="-270"/>
      </p:cViewPr>
      <p:guideLst>
        <p:guide orient="horz" pos="1774"/>
        <p:guide pos="1593"/>
        <p:guide pos="301"/>
        <p:guide pos="70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481916" y="428232"/>
            <a:ext cx="1701284" cy="912404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78063" y="428232"/>
            <a:ext cx="4977831" cy="912404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78063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843642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Laengsschnitt_fire_mit_morphing_clipped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-2" y="4032415"/>
            <a:ext cx="7561263" cy="1890713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567757" y="974686"/>
            <a:ext cx="1244764" cy="36933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24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deo</a:t>
            </a:r>
            <a:r>
              <a:rPr lang="en-GB" sz="24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GB" sz="2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785244" y="8516857"/>
            <a:ext cx="5711090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Video</a:t>
            </a:r>
            <a:r>
              <a:rPr lang="en-GB" b="1" dirty="0" smtClean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 S1,</a:t>
            </a:r>
            <a:r>
              <a:rPr lang="en-GB" dirty="0" smtClean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 Video is </a:t>
            </a:r>
            <a:r>
              <a:rPr lang="en-GB" dirty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showing </a:t>
            </a:r>
            <a:r>
              <a:rPr lang="en-GB" dirty="0" smtClean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the virtual </a:t>
            </a:r>
            <a:r>
              <a:rPr lang="en-GB" dirty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4-D model visualising the growing caryopsis in the </a:t>
            </a:r>
            <a:r>
              <a:rPr lang="en-GB" dirty="0" smtClean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longitudinal direction.</a:t>
            </a:r>
            <a:endParaRPr lang="en-GB" dirty="0">
              <a:solidFill>
                <a:schemeClr val="bg1"/>
              </a:solidFill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9511323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blank">
  <a:themeElements>
    <a:clrScheme name="Graustuf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spDef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lIns="0" tIns="0" rIns="0" bIns="0" rtlCol="0">
        <a:spAutoFit/>
      </a:bodyPr>
      <a:lstStyle>
        <a:defPPr>
          <a:defRPr dirty="0"/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21</Words>
  <Application>Microsoft Office PowerPoint</Application>
  <PresentationFormat>Benutzerdefiniert</PresentationFormat>
  <Paragraphs>2</Paragraphs>
  <Slides>1</Slides>
  <Notes>0</Notes>
  <HiddenSlides>0</HiddenSlides>
  <MMClips>1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blank</vt:lpstr>
      <vt:lpstr>PowerPoint-Präsentation</vt:lpstr>
    </vt:vector>
  </TitlesOfParts>
  <Company>IPK Gatersleb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lipfert</dc:creator>
  <cp:lastModifiedBy>Hans Weber</cp:lastModifiedBy>
  <cp:revision>170</cp:revision>
  <cp:lastPrinted>2014-12-19T10:07:57Z</cp:lastPrinted>
  <dcterms:created xsi:type="dcterms:W3CDTF">2013-08-29T07:15:11Z</dcterms:created>
  <dcterms:modified xsi:type="dcterms:W3CDTF">2015-07-29T08:08:29Z</dcterms:modified>
</cp:coreProperties>
</file>